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8D923-2741-4357-A267-7A3A8800FC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1C42F7-B830-4582-BBEA-45E18AE74F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A7F4C-42A6-4FDE-B803-9DFC0B43B2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7D58F-3017-4E9E-8867-FDC66B5007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69CBF-92F7-43A7-92B3-5C433B672F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84D93D-E337-4ADA-B0D4-8B9DE099D3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6DF7C-ACD0-481E-AB00-BE57868F73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F7B05-E159-48B7-8A19-B234A34941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1AF053-120C-43F2-B7F3-B0E4DA98C8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27C70-78CC-4307-8D0E-52AB562142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72D86-3342-4395-945B-95A5E8ED97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EC374-16CB-46CB-9443-2C4068BA4C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5BD839-A1F1-41FE-A496-13B70A9742D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557280" y="652320"/>
            <a:ext cx="5843520" cy="2374920"/>
            <a:chOff x="557280" y="652320"/>
            <a:chExt cx="5843520" cy="2374920"/>
          </a:xfrm>
        </p:grpSpPr>
        <p:pic>
          <p:nvPicPr>
            <p:cNvPr id="42" name="Picture 3" descr=""/>
            <p:cNvPicPr/>
            <p:nvPr/>
          </p:nvPicPr>
          <p:blipFill>
            <a:blip r:embed="rId1"/>
            <a:stretch/>
          </p:blipFill>
          <p:spPr>
            <a:xfrm>
              <a:off x="557280" y="2247480"/>
              <a:ext cx="5843520" cy="779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4" descr=""/>
            <p:cNvPicPr/>
            <p:nvPr/>
          </p:nvPicPr>
          <p:blipFill>
            <a:blip r:embed="rId2"/>
            <a:stretch/>
          </p:blipFill>
          <p:spPr>
            <a:xfrm>
              <a:off x="557280" y="1456920"/>
              <a:ext cx="5835960" cy="81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21" descr="C:\Documents and Settings\a\Desktop\Picture1.jpg"/>
            <p:cNvPicPr/>
            <p:nvPr/>
          </p:nvPicPr>
          <p:blipFill>
            <a:blip r:embed="rId3"/>
            <a:stretch/>
          </p:blipFill>
          <p:spPr>
            <a:xfrm>
              <a:off x="557280" y="652320"/>
              <a:ext cx="5839920" cy="8125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5" name="Group 5"/>
          <p:cNvGrpSpPr/>
          <p:nvPr/>
        </p:nvGrpSpPr>
        <p:grpSpPr>
          <a:xfrm>
            <a:off x="557280" y="3097080"/>
            <a:ext cx="5843520" cy="2451240"/>
            <a:chOff x="557280" y="3097080"/>
            <a:chExt cx="5843520" cy="2451240"/>
          </a:xfrm>
        </p:grpSpPr>
        <p:pic>
          <p:nvPicPr>
            <p:cNvPr id="46" name="Picture 2" descr=""/>
            <p:cNvPicPr/>
            <p:nvPr/>
          </p:nvPicPr>
          <p:blipFill>
            <a:blip r:embed="rId4"/>
            <a:stretch/>
          </p:blipFill>
          <p:spPr>
            <a:xfrm>
              <a:off x="557280" y="3097080"/>
              <a:ext cx="5834880" cy="812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3" descr=""/>
            <p:cNvPicPr/>
            <p:nvPr/>
          </p:nvPicPr>
          <p:blipFill>
            <a:blip r:embed="rId5"/>
            <a:stretch/>
          </p:blipFill>
          <p:spPr>
            <a:xfrm>
              <a:off x="557280" y="3877560"/>
              <a:ext cx="5825880" cy="83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4" descr=""/>
            <p:cNvPicPr/>
            <p:nvPr/>
          </p:nvPicPr>
          <p:blipFill>
            <a:blip r:embed="rId6"/>
            <a:stretch/>
          </p:blipFill>
          <p:spPr>
            <a:xfrm>
              <a:off x="561600" y="4701960"/>
              <a:ext cx="5839200" cy="846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9" name="Group 13"/>
          <p:cNvGrpSpPr/>
          <p:nvPr/>
        </p:nvGrpSpPr>
        <p:grpSpPr>
          <a:xfrm>
            <a:off x="561960" y="5624640"/>
            <a:ext cx="5838840" cy="2209680"/>
            <a:chOff x="561960" y="5624640"/>
            <a:chExt cx="5838840" cy="2209680"/>
          </a:xfrm>
        </p:grpSpPr>
        <p:pic>
          <p:nvPicPr>
            <p:cNvPr id="50" name="Picture 4" descr="C:\Documents and Settings\a\Desktop\Picture5.jpg"/>
            <p:cNvPicPr/>
            <p:nvPr/>
          </p:nvPicPr>
          <p:blipFill>
            <a:blip r:embed="rId7"/>
            <a:stretch/>
          </p:blipFill>
          <p:spPr>
            <a:xfrm>
              <a:off x="561960" y="6341400"/>
              <a:ext cx="5832360" cy="777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57" descr=""/>
            <p:cNvPicPr/>
            <p:nvPr/>
          </p:nvPicPr>
          <p:blipFill>
            <a:blip r:embed="rId8"/>
            <a:stretch/>
          </p:blipFill>
          <p:spPr>
            <a:xfrm>
              <a:off x="565200" y="7089840"/>
              <a:ext cx="5828040" cy="744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5" descr=""/>
            <p:cNvPicPr/>
            <p:nvPr/>
          </p:nvPicPr>
          <p:blipFill>
            <a:blip r:embed="rId9"/>
            <a:stretch/>
          </p:blipFill>
          <p:spPr>
            <a:xfrm>
              <a:off x="564120" y="5624640"/>
              <a:ext cx="5836680" cy="744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3" name="TextBox 5"/>
          <p:cNvSpPr/>
          <p:nvPr/>
        </p:nvSpPr>
        <p:spPr>
          <a:xfrm>
            <a:off x="490680" y="412920"/>
            <a:ext cx="109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6"/>
          <p:cNvSpPr/>
          <p:nvPr/>
        </p:nvSpPr>
        <p:spPr>
          <a:xfrm>
            <a:off x="2421000" y="412920"/>
            <a:ext cx="109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25 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7"/>
          <p:cNvSpPr/>
          <p:nvPr/>
        </p:nvSpPr>
        <p:spPr>
          <a:xfrm>
            <a:off x="3389400" y="412920"/>
            <a:ext cx="109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25 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8"/>
          <p:cNvSpPr/>
          <p:nvPr/>
        </p:nvSpPr>
        <p:spPr>
          <a:xfrm>
            <a:off x="4379760" y="412920"/>
            <a:ext cx="109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25 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9"/>
          <p:cNvSpPr/>
          <p:nvPr/>
        </p:nvSpPr>
        <p:spPr>
          <a:xfrm>
            <a:off x="5316480" y="412920"/>
            <a:ext cx="109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25  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0"/>
          <p:cNvSpPr/>
          <p:nvPr/>
        </p:nvSpPr>
        <p:spPr>
          <a:xfrm>
            <a:off x="1473120" y="412920"/>
            <a:ext cx="109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25  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"/>
          <p:cNvSpPr/>
          <p:nvPr/>
        </p:nvSpPr>
        <p:spPr>
          <a:xfrm>
            <a:off x="-158760" y="70956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.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3"/>
          <p:cNvSpPr/>
          <p:nvPr/>
        </p:nvSpPr>
        <p:spPr>
          <a:xfrm>
            <a:off x="-163440" y="32004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.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4"/>
          <p:cNvSpPr/>
          <p:nvPr/>
        </p:nvSpPr>
        <p:spPr>
          <a:xfrm>
            <a:off x="-162000" y="57150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.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1"/>
          <p:cNvSpPr/>
          <p:nvPr/>
        </p:nvSpPr>
        <p:spPr>
          <a:xfrm>
            <a:off x="492120" y="8001000"/>
            <a:ext cx="590868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 Control and T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ogeny of transgenic lines Ab25 C, Ab25 B, Ab25 A, Ab25 D and Ab25 E subjected to feeding assay by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. litur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Leaf area damage was calculated by the cut paper metho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30T10:06:11Z</dcterms:created>
  <dc:creator>a</dc:creator>
  <dc:description/>
  <dc:language>en-US</dc:language>
  <cp:lastModifiedBy> </cp:lastModifiedBy>
  <dcterms:modified xsi:type="dcterms:W3CDTF">2014-01-28T12:46:33Z</dcterms:modified>
  <cp:revision>33</cp:revision>
  <dc:subject/>
  <dc:title>Slide 1</dc:title>
</cp:coreProperties>
</file>